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4982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4821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658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2581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5442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4287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8987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2364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721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2107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610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D6A1A8-6757-4C1B-AC69-D7F0186AE21A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E9431-67D5-4181-A62D-5E466429A7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3499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4.tiff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3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tiff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/>
          <a:srcRect l="20780"/>
          <a:stretch/>
        </p:blipFill>
        <p:spPr>
          <a:xfrm>
            <a:off x="3536576" y="1981199"/>
            <a:ext cx="1734670" cy="8023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/>
          <a:srcRect l="16234" t="4636"/>
          <a:stretch/>
        </p:blipFill>
        <p:spPr>
          <a:xfrm>
            <a:off x="3536576" y="2877671"/>
            <a:ext cx="1734668" cy="4840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4"/>
          <a:srcRect l="9091" t="-662"/>
          <a:stretch/>
        </p:blipFill>
        <p:spPr>
          <a:xfrm>
            <a:off x="3536575" y="3429000"/>
            <a:ext cx="1734667" cy="5109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55" t="50848" r="48281" b="32857"/>
          <a:stretch/>
        </p:blipFill>
        <p:spPr>
          <a:xfrm>
            <a:off x="3536575" y="3980329"/>
            <a:ext cx="1734668" cy="6135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05" t="29074" r="49567" b="58214"/>
          <a:stretch/>
        </p:blipFill>
        <p:spPr>
          <a:xfrm>
            <a:off x="3536575" y="4666129"/>
            <a:ext cx="1734667" cy="6992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文本框 12"/>
          <p:cNvSpPr txBox="1"/>
          <p:nvPr/>
        </p:nvSpPr>
        <p:spPr>
          <a:xfrm>
            <a:off x="3012141" y="1331259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769656" y="1349189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110314" y="1353672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486830" y="1367119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827488" y="1371602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989730" y="1658470"/>
            <a:ext cx="6912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787586" y="1676400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128244" y="1680883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504760" y="1694330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845418" y="1698813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121864" y="940824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3821608" y="1331424"/>
            <a:ext cx="12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5257796" y="2191399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289173" y="2962361"/>
            <a:ext cx="21675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</a:t>
            </a:r>
            <a:r>
              <a:rPr lang="en-US" altLang="zh-CN" sz="1600" dirty="0" err="1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EGFR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(pY1068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5293656" y="3531618"/>
            <a:ext cx="1152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GFR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271245" y="4867354"/>
            <a:ext cx="12891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RK1/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289175" y="3957441"/>
            <a:ext cx="140294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pERK1/2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T202/Y204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916163" y="2193089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1" name="直接连接符 30"/>
          <p:cNvCxnSpPr/>
          <p:nvPr/>
        </p:nvCxnSpPr>
        <p:spPr>
          <a:xfrm>
            <a:off x="3355349" y="2348919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2920646" y="296405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3" name="直接连接符 32"/>
          <p:cNvCxnSpPr/>
          <p:nvPr/>
        </p:nvCxnSpPr>
        <p:spPr>
          <a:xfrm>
            <a:off x="3359832" y="3119881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2938576" y="3492967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5" name="直接连接符 34"/>
          <p:cNvCxnSpPr/>
          <p:nvPr/>
        </p:nvCxnSpPr>
        <p:spPr>
          <a:xfrm>
            <a:off x="3377762" y="3648797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3050635" y="4196694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3382245" y="4339077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3028224" y="491386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3359834" y="5056251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241030" y="226332"/>
            <a:ext cx="4044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c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7560550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3713" y="2175901"/>
            <a:ext cx="1617569" cy="7690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/>
          <a:srcRect b="30533"/>
          <a:stretch/>
        </p:blipFill>
        <p:spPr>
          <a:xfrm>
            <a:off x="3263712" y="3004016"/>
            <a:ext cx="1617569" cy="7342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3711" y="3797394"/>
            <a:ext cx="1617569" cy="5997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文本框 9"/>
          <p:cNvSpPr txBox="1"/>
          <p:nvPr/>
        </p:nvSpPr>
        <p:spPr>
          <a:xfrm>
            <a:off x="4881280" y="2460339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912657" y="3231301"/>
            <a:ext cx="21675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</a:t>
            </a:r>
            <a:r>
              <a:rPr lang="en-US" altLang="zh-CN" sz="1600" dirty="0" err="1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EGFR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(pY1068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917140" y="3881240"/>
            <a:ext cx="1152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GFR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92" t="28162" r="15021" b="59034"/>
          <a:stretch/>
        </p:blipFill>
        <p:spPr>
          <a:xfrm>
            <a:off x="3272116" y="5101756"/>
            <a:ext cx="1609164" cy="5647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278" t="52246" r="15021" b="34035"/>
          <a:stretch/>
        </p:blipFill>
        <p:spPr>
          <a:xfrm>
            <a:off x="3263710" y="4448179"/>
            <a:ext cx="1617569" cy="6051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文本框 14"/>
          <p:cNvSpPr txBox="1"/>
          <p:nvPr/>
        </p:nvSpPr>
        <p:spPr>
          <a:xfrm>
            <a:off x="4894729" y="5230423"/>
            <a:ext cx="12891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RK1/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912659" y="4508768"/>
            <a:ext cx="140294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pERK1/2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T202/Y204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702860" y="1506070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460375" y="1524000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801033" y="1528483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177549" y="1541930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518207" y="1546413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680449" y="1833281"/>
            <a:ext cx="6912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478305" y="1851211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3818963" y="1855694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195479" y="1869141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536137" y="1873624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2620329" y="2488923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8" name="直接连接符 27"/>
          <p:cNvCxnSpPr/>
          <p:nvPr/>
        </p:nvCxnSpPr>
        <p:spPr>
          <a:xfrm>
            <a:off x="3059515" y="2644753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2624812" y="336746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3" name="直接连接符 32"/>
          <p:cNvCxnSpPr/>
          <p:nvPr/>
        </p:nvCxnSpPr>
        <p:spPr>
          <a:xfrm>
            <a:off x="3063998" y="3523291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2642742" y="3963612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5" name="直接连接符 34"/>
          <p:cNvCxnSpPr/>
          <p:nvPr/>
        </p:nvCxnSpPr>
        <p:spPr>
          <a:xfrm>
            <a:off x="3081928" y="4119442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2754801" y="470768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3086411" y="4850063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2732390" y="5276937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3064000" y="5419320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3812583" y="1115635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1" name="直接连接符 40"/>
          <p:cNvCxnSpPr/>
          <p:nvPr/>
        </p:nvCxnSpPr>
        <p:spPr>
          <a:xfrm>
            <a:off x="3512327" y="1506235"/>
            <a:ext cx="12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241030" y="226332"/>
            <a:ext cx="4044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c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09775" y="919162"/>
            <a:ext cx="5124450" cy="5019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19884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41030" y="226332"/>
            <a:ext cx="4044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c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50" t="26786" r="34479" b="57143"/>
          <a:stretch/>
        </p:blipFill>
        <p:spPr>
          <a:xfrm>
            <a:off x="3315093" y="4512192"/>
            <a:ext cx="1708025" cy="6732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/>
          <p:cNvSpPr txBox="1"/>
          <p:nvPr/>
        </p:nvSpPr>
        <p:spPr>
          <a:xfrm>
            <a:off x="2611367" y="1522117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368882" y="1540047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824835" y="1544530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247420" y="1557977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637384" y="1562460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588956" y="1849328"/>
            <a:ext cx="6912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386812" y="186725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799187" y="1871741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265350" y="188518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637384" y="1889671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788325" y="1131682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3420834" y="1522282"/>
            <a:ext cx="14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5063418" y="5494944"/>
            <a:ext cx="12891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RK1/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063418" y="4572878"/>
            <a:ext cx="140294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pERK1/2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T202/Y204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795266" y="481909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3126876" y="4961482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470" t="42640" r="34523" b="43147"/>
          <a:stretch/>
        </p:blipFill>
        <p:spPr>
          <a:xfrm>
            <a:off x="3324281" y="2248886"/>
            <a:ext cx="1710000" cy="7220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44" t="23319" r="27036" b="61425"/>
          <a:stretch/>
        </p:blipFill>
        <p:spPr>
          <a:xfrm>
            <a:off x="3324281" y="3011731"/>
            <a:ext cx="1698838" cy="711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15093" y="3789441"/>
            <a:ext cx="1708025" cy="6390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12" t="38207" r="51445" b="50831"/>
          <a:stretch/>
        </p:blipFill>
        <p:spPr>
          <a:xfrm>
            <a:off x="3324281" y="5252898"/>
            <a:ext cx="1698837" cy="7692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文本框 23"/>
          <p:cNvSpPr txBox="1"/>
          <p:nvPr/>
        </p:nvSpPr>
        <p:spPr>
          <a:xfrm>
            <a:off x="5063418" y="2545445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063418" y="3155043"/>
            <a:ext cx="21675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</a:t>
            </a:r>
            <a:r>
              <a:rPr lang="en-US" altLang="zh-CN" sz="1600" dirty="0" err="1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EGFR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(pY1068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063418" y="3993240"/>
            <a:ext cx="1152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GFR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2799749" y="560350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8" name="直接连接符 27"/>
          <p:cNvCxnSpPr/>
          <p:nvPr/>
        </p:nvCxnSpPr>
        <p:spPr>
          <a:xfrm>
            <a:off x="3131359" y="5745891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2687568" y="4026304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3126754" y="4182134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2692051" y="331809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3131237" y="3473926"/>
            <a:ext cx="1812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025842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41030" y="226332"/>
            <a:ext cx="49103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c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23339"/>
            <a:ext cx="9144000" cy="26113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690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</TotalTime>
  <Words>106</Words>
  <Application>Microsoft Office PowerPoint</Application>
  <PresentationFormat>全屏显示(4:3)</PresentationFormat>
  <Paragraphs>6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0</cp:revision>
  <dcterms:created xsi:type="dcterms:W3CDTF">2020-08-31T01:25:00Z</dcterms:created>
  <dcterms:modified xsi:type="dcterms:W3CDTF">2020-10-12T07:52:08Z</dcterms:modified>
</cp:coreProperties>
</file>